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5" d="100"/>
          <a:sy n="75" d="100"/>
        </p:scale>
        <p:origin x="522" y="-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ULEMA VALERO CUESTA" userId="7c0a58d0-13c0-4f22-8c26-82db3ac15929" providerId="ADAL" clId="{2E13A150-E06A-406E-A813-AC72DA92E004}"/>
    <pc:docChg chg="undo custSel modSld">
      <pc:chgData name="YULEMA VALERO CUESTA" userId="7c0a58d0-13c0-4f22-8c26-82db3ac15929" providerId="ADAL" clId="{2E13A150-E06A-406E-A813-AC72DA92E004}" dt="2024-02-16T09:08:55.990" v="119" actId="114"/>
      <pc:docMkLst>
        <pc:docMk/>
      </pc:docMkLst>
      <pc:sldChg chg="modSp mod">
        <pc:chgData name="YULEMA VALERO CUESTA" userId="7c0a58d0-13c0-4f22-8c26-82db3ac15929" providerId="ADAL" clId="{2E13A150-E06A-406E-A813-AC72DA92E004}" dt="2024-02-16T09:08:55.990" v="119" actId="114"/>
        <pc:sldMkLst>
          <pc:docMk/>
          <pc:sldMk cId="703391924" sldId="257"/>
        </pc:sldMkLst>
        <pc:spChg chg="mod">
          <ac:chgData name="YULEMA VALERO CUESTA" userId="7c0a58d0-13c0-4f22-8c26-82db3ac15929" providerId="ADAL" clId="{2E13A150-E06A-406E-A813-AC72DA92E004}" dt="2024-02-16T09:07:07.158" v="14" actId="114"/>
          <ac:spMkLst>
            <pc:docMk/>
            <pc:sldMk cId="703391924" sldId="257"/>
            <ac:spMk id="4" creationId="{35C65687-1C66-F067-6E6B-9D5FB5AA8447}"/>
          </ac:spMkLst>
        </pc:spChg>
        <pc:spChg chg="mod">
          <ac:chgData name="YULEMA VALERO CUESTA" userId="7c0a58d0-13c0-4f22-8c26-82db3ac15929" providerId="ADAL" clId="{2E13A150-E06A-406E-A813-AC72DA92E004}" dt="2024-02-16T09:08:05.324" v="47" actId="20577"/>
          <ac:spMkLst>
            <pc:docMk/>
            <pc:sldMk cId="703391924" sldId="257"/>
            <ac:spMk id="5" creationId="{20FA7312-CD72-B8D4-B594-8CB52578BB6B}"/>
          </ac:spMkLst>
        </pc:spChg>
        <pc:spChg chg="mod">
          <ac:chgData name="YULEMA VALERO CUESTA" userId="7c0a58d0-13c0-4f22-8c26-82db3ac15929" providerId="ADAL" clId="{2E13A150-E06A-406E-A813-AC72DA92E004}" dt="2024-02-16T09:08:55.990" v="119" actId="114"/>
          <ac:spMkLst>
            <pc:docMk/>
            <pc:sldMk cId="703391924" sldId="257"/>
            <ac:spMk id="22" creationId="{E2502205-DBD4-03BF-CC17-F907E32AFA4C}"/>
          </ac:spMkLst>
        </pc:spChg>
        <pc:spChg chg="mod">
          <ac:chgData name="YULEMA VALERO CUESTA" userId="7c0a58d0-13c0-4f22-8c26-82db3ac15929" providerId="ADAL" clId="{2E13A150-E06A-406E-A813-AC72DA92E004}" dt="2024-02-16T09:08:39.341" v="87" actId="20577"/>
          <ac:spMkLst>
            <pc:docMk/>
            <pc:sldMk cId="703391924" sldId="257"/>
            <ac:spMk id="25" creationId="{FC9AFFF8-2518-24DF-A5B8-103762DD1480}"/>
          </ac:spMkLst>
        </pc:spChg>
        <pc:spChg chg="mod">
          <ac:chgData name="YULEMA VALERO CUESTA" userId="7c0a58d0-13c0-4f22-8c26-82db3ac15929" providerId="ADAL" clId="{2E13A150-E06A-406E-A813-AC72DA92E004}" dt="2024-02-16T09:07:30.502" v="22" actId="114"/>
          <ac:spMkLst>
            <pc:docMk/>
            <pc:sldMk cId="703391924" sldId="257"/>
            <ac:spMk id="30" creationId="{B74FB3E0-5429-88F5-B939-05975E563AAF}"/>
          </ac:spMkLst>
        </pc:spChg>
        <pc:spChg chg="mod">
          <ac:chgData name="YULEMA VALERO CUESTA" userId="7c0a58d0-13c0-4f22-8c26-82db3ac15929" providerId="ADAL" clId="{2E13A150-E06A-406E-A813-AC72DA92E004}" dt="2024-02-16T09:07:39.085" v="29" actId="114"/>
          <ac:spMkLst>
            <pc:docMk/>
            <pc:sldMk cId="703391924" sldId="257"/>
            <ac:spMk id="32" creationId="{6CAEC285-73C9-63CD-3345-3E2F3A274BAB}"/>
          </ac:spMkLst>
        </pc:spChg>
        <pc:spChg chg="mod">
          <ac:chgData name="YULEMA VALERO CUESTA" userId="7c0a58d0-13c0-4f22-8c26-82db3ac15929" providerId="ADAL" clId="{2E13A150-E06A-406E-A813-AC72DA92E004}" dt="2024-02-16T09:06:54.015" v="6" actId="114"/>
          <ac:spMkLst>
            <pc:docMk/>
            <pc:sldMk cId="703391924" sldId="257"/>
            <ac:spMk id="44" creationId="{C201AEEF-13F0-26AD-2420-E2AB16722448}"/>
          </ac:spMkLst>
        </pc:spChg>
        <pc:grpChg chg="ord">
          <ac:chgData name="YULEMA VALERO CUESTA" userId="7c0a58d0-13c0-4f22-8c26-82db3ac15929" providerId="ADAL" clId="{2E13A150-E06A-406E-A813-AC72DA92E004}" dt="2024-02-16T09:07:22.327" v="15" actId="167"/>
          <ac:grpSpMkLst>
            <pc:docMk/>
            <pc:sldMk cId="703391924" sldId="257"/>
            <ac:grpSpMk id="3" creationId="{B3972B57-6189-9D37-13EB-0F621C400C8B}"/>
          </ac:grpSpMkLst>
        </pc:grpChg>
        <pc:grpChg chg="ord">
          <ac:chgData name="YULEMA VALERO CUESTA" userId="7c0a58d0-13c0-4f22-8c26-82db3ac15929" providerId="ADAL" clId="{2E13A150-E06A-406E-A813-AC72DA92E004}" dt="2024-02-16T09:07:48.967" v="30" actId="167"/>
          <ac:grpSpMkLst>
            <pc:docMk/>
            <pc:sldMk cId="703391924" sldId="257"/>
            <ac:grpSpMk id="43" creationId="{23B0A55B-C8E1-9F8B-30DF-24245BBF8101}"/>
          </ac:grpSpMkLst>
        </pc:grpChg>
        <pc:picChg chg="ord">
          <ac:chgData name="YULEMA VALERO CUESTA" userId="7c0a58d0-13c0-4f22-8c26-82db3ac15929" providerId="ADAL" clId="{2E13A150-E06A-406E-A813-AC72DA92E004}" dt="2024-02-16T09:08:13.340" v="48" actId="167"/>
          <ac:picMkLst>
            <pc:docMk/>
            <pc:sldMk cId="703391924" sldId="257"/>
            <ac:picMk id="7" creationId="{23663318-3064-A602-411C-49C6E45BA6C9}"/>
          </ac:picMkLst>
        </pc:picChg>
        <pc:picChg chg="ord">
          <ac:chgData name="YULEMA VALERO CUESTA" userId="7c0a58d0-13c0-4f22-8c26-82db3ac15929" providerId="ADAL" clId="{2E13A150-E06A-406E-A813-AC72DA92E004}" dt="2024-02-16T09:06:59.297" v="7" actId="167"/>
          <ac:picMkLst>
            <pc:docMk/>
            <pc:sldMk cId="703391924" sldId="257"/>
            <ac:picMk id="8" creationId="{47F6E0BB-2B7D-4DEF-225E-BBA244C2DDBC}"/>
          </ac:picMkLst>
        </pc:picChg>
        <pc:picChg chg="ord">
          <ac:chgData name="YULEMA VALERO CUESTA" userId="7c0a58d0-13c0-4f22-8c26-82db3ac15929" providerId="ADAL" clId="{2E13A150-E06A-406E-A813-AC72DA92E004}" dt="2024-02-16T09:07:52.371" v="31" actId="167"/>
          <ac:picMkLst>
            <pc:docMk/>
            <pc:sldMk cId="703391924" sldId="257"/>
            <ac:picMk id="9" creationId="{793E8338-1EF6-9989-18E3-C7710E22F2D9}"/>
          </ac:picMkLst>
        </pc:picChg>
      </pc:sldChg>
    </pc:docChg>
  </pc:docChgLst>
  <pc:docChgLst>
    <pc:chgData name="YULEMA VALERO CUESTA" userId="7c0a58d0-13c0-4f22-8c26-82db3ac15929" providerId="ADAL" clId="{CB5E2D25-B923-485A-A9CB-54C19EB0B4F5}"/>
    <pc:docChg chg="modSld">
      <pc:chgData name="YULEMA VALERO CUESTA" userId="7c0a58d0-13c0-4f22-8c26-82db3ac15929" providerId="ADAL" clId="{CB5E2D25-B923-485A-A9CB-54C19EB0B4F5}" dt="2024-03-18T07:24:48.291" v="22" actId="1038"/>
      <pc:docMkLst>
        <pc:docMk/>
      </pc:docMkLst>
      <pc:sldChg chg="modSp mod">
        <pc:chgData name="YULEMA VALERO CUESTA" userId="7c0a58d0-13c0-4f22-8c26-82db3ac15929" providerId="ADAL" clId="{CB5E2D25-B923-485A-A9CB-54C19EB0B4F5}" dt="2024-03-18T07:24:48.291" v="22" actId="1038"/>
        <pc:sldMkLst>
          <pc:docMk/>
          <pc:sldMk cId="703391924" sldId="257"/>
        </pc:sldMkLst>
        <pc:spChg chg="mod">
          <ac:chgData name="YULEMA VALERO CUESTA" userId="7c0a58d0-13c0-4f22-8c26-82db3ac15929" providerId="ADAL" clId="{CB5E2D25-B923-485A-A9CB-54C19EB0B4F5}" dt="2024-03-18T07:24:48.291" v="22" actId="1038"/>
          <ac:spMkLst>
            <pc:docMk/>
            <pc:sldMk cId="703391924" sldId="257"/>
            <ac:spMk id="5" creationId="{20FA7312-CD72-B8D4-B594-8CB52578BB6B}"/>
          </ac:spMkLst>
        </pc:spChg>
      </pc:sldChg>
    </pc:docChg>
  </pc:docChgLst>
  <pc:docChgLst>
    <pc:chgData name="YULEMA VALERO CUESTA" userId="7c0a58d0-13c0-4f22-8c26-82db3ac15929" providerId="ADAL" clId="{237D5313-6942-44B0-92D9-66721B7DFF0F}"/>
    <pc:docChg chg="modSld">
      <pc:chgData name="YULEMA VALERO CUESTA" userId="7c0a58d0-13c0-4f22-8c26-82db3ac15929" providerId="ADAL" clId="{237D5313-6942-44B0-92D9-66721B7DFF0F}" dt="2024-06-01T13:23:00.456" v="0" actId="20577"/>
      <pc:docMkLst>
        <pc:docMk/>
      </pc:docMkLst>
      <pc:sldChg chg="modSp mod">
        <pc:chgData name="YULEMA VALERO CUESTA" userId="7c0a58d0-13c0-4f22-8c26-82db3ac15929" providerId="ADAL" clId="{237D5313-6942-44B0-92D9-66721B7DFF0F}" dt="2024-06-01T13:23:00.456" v="0" actId="20577"/>
        <pc:sldMkLst>
          <pc:docMk/>
          <pc:sldMk cId="703391924" sldId="257"/>
        </pc:sldMkLst>
        <pc:spChg chg="mod">
          <ac:chgData name="YULEMA VALERO CUESTA" userId="7c0a58d0-13c0-4f22-8c26-82db3ac15929" providerId="ADAL" clId="{237D5313-6942-44B0-92D9-66721B7DFF0F}" dt="2024-06-01T13:23:00.456" v="0" actId="20577"/>
          <ac:spMkLst>
            <pc:docMk/>
            <pc:sldMk cId="703391924" sldId="257"/>
            <ac:spMk id="2" creationId="{04810AC8-7D5F-50D1-50F1-E295D5B109A4}"/>
          </ac:spMkLst>
        </pc:spChg>
      </pc:sldChg>
    </pc:docChg>
  </pc:docChgLst>
  <pc:docChgLst>
    <pc:chgData name="YULEMA VALERO CUESTA" userId="7c0a58d0-13c0-4f22-8c26-82db3ac15929" providerId="ADAL" clId="{BE2DCED9-2DC4-485F-877D-6653E6F8695E}"/>
    <pc:docChg chg="undo custSel modSld">
      <pc:chgData name="YULEMA VALERO CUESTA" userId="7c0a58d0-13c0-4f22-8c26-82db3ac15929" providerId="ADAL" clId="{BE2DCED9-2DC4-485F-877D-6653E6F8695E}" dt="2023-12-17T06:33:02.234" v="152" actId="1076"/>
      <pc:docMkLst>
        <pc:docMk/>
      </pc:docMkLst>
      <pc:sldChg chg="addSp modSp mod">
        <pc:chgData name="YULEMA VALERO CUESTA" userId="7c0a58d0-13c0-4f22-8c26-82db3ac15929" providerId="ADAL" clId="{BE2DCED9-2DC4-485F-877D-6653E6F8695E}" dt="2023-12-17T06:33:02.234" v="152" actId="1076"/>
        <pc:sldMkLst>
          <pc:docMk/>
          <pc:sldMk cId="703391924" sldId="257"/>
        </pc:sldMkLst>
        <pc:spChg chg="add mod">
          <ac:chgData name="YULEMA VALERO CUESTA" userId="7c0a58d0-13c0-4f22-8c26-82db3ac15929" providerId="ADAL" clId="{BE2DCED9-2DC4-485F-877D-6653E6F8695E}" dt="2023-12-17T06:31:29.587" v="141" actId="1037"/>
          <ac:spMkLst>
            <pc:docMk/>
            <pc:sldMk cId="703391924" sldId="257"/>
            <ac:spMk id="4" creationId="{35C65687-1C66-F067-6E6B-9D5FB5AA8447}"/>
          </ac:spMkLst>
        </pc:spChg>
        <pc:spChg chg="mod">
          <ac:chgData name="YULEMA VALERO CUESTA" userId="7c0a58d0-13c0-4f22-8c26-82db3ac15929" providerId="ADAL" clId="{BE2DCED9-2DC4-485F-877D-6653E6F8695E}" dt="2023-12-17T06:28:42.506" v="54" actId="164"/>
          <ac:spMkLst>
            <pc:docMk/>
            <pc:sldMk cId="703391924" sldId="257"/>
            <ac:spMk id="44" creationId="{C201AEEF-13F0-26AD-2420-E2AB16722448}"/>
          </ac:spMkLst>
        </pc:spChg>
        <pc:grpChg chg="add mod">
          <ac:chgData name="YULEMA VALERO CUESTA" userId="7c0a58d0-13c0-4f22-8c26-82db3ac15929" providerId="ADAL" clId="{BE2DCED9-2DC4-485F-877D-6653E6F8695E}" dt="2023-12-17T06:28:46.093" v="55" actId="1076"/>
          <ac:grpSpMkLst>
            <pc:docMk/>
            <pc:sldMk cId="703391924" sldId="257"/>
            <ac:grpSpMk id="3" creationId="{B3972B57-6189-9D37-13EB-0F621C400C8B}"/>
          </ac:grpSpMkLst>
        </pc:grpChg>
        <pc:grpChg chg="mod">
          <ac:chgData name="YULEMA VALERO CUESTA" userId="7c0a58d0-13c0-4f22-8c26-82db3ac15929" providerId="ADAL" clId="{BE2DCED9-2DC4-485F-877D-6653E6F8695E}" dt="2023-12-17T06:28:15.372" v="2" actId="1076"/>
          <ac:grpSpMkLst>
            <pc:docMk/>
            <pc:sldMk cId="703391924" sldId="257"/>
            <ac:grpSpMk id="31" creationId="{8BDDB484-72FA-CB90-687A-0D747B85186E}"/>
          </ac:grpSpMkLst>
        </pc:grpChg>
        <pc:grpChg chg="mod">
          <ac:chgData name="YULEMA VALERO CUESTA" userId="7c0a58d0-13c0-4f22-8c26-82db3ac15929" providerId="ADAL" clId="{BE2DCED9-2DC4-485F-877D-6653E6F8695E}" dt="2023-12-17T06:28:29.384" v="51" actId="1037"/>
          <ac:grpSpMkLst>
            <pc:docMk/>
            <pc:sldMk cId="703391924" sldId="257"/>
            <ac:grpSpMk id="35" creationId="{D42E89A3-97D4-AB03-E610-2F5D3D4C7538}"/>
          </ac:grpSpMkLst>
        </pc:grpChg>
        <pc:picChg chg="add mod">
          <ac:chgData name="YULEMA VALERO CUESTA" userId="7c0a58d0-13c0-4f22-8c26-82db3ac15929" providerId="ADAL" clId="{BE2DCED9-2DC4-485F-877D-6653E6F8695E}" dt="2023-12-17T06:33:02.234" v="152" actId="1076"/>
          <ac:picMkLst>
            <pc:docMk/>
            <pc:sldMk cId="703391924" sldId="257"/>
            <ac:picMk id="8" creationId="{47F6E0BB-2B7D-4DEF-225E-BBA244C2DDBC}"/>
          </ac:picMkLst>
        </pc:picChg>
        <pc:picChg chg="mod">
          <ac:chgData name="YULEMA VALERO CUESTA" userId="7c0a58d0-13c0-4f22-8c26-82db3ac15929" providerId="ADAL" clId="{BE2DCED9-2DC4-485F-877D-6653E6F8695E}" dt="2023-12-17T06:28:42.506" v="54" actId="164"/>
          <ac:picMkLst>
            <pc:docMk/>
            <pc:sldMk cId="703391924" sldId="257"/>
            <ac:picMk id="46" creationId="{168BD127-1D5F-A543-4A38-50CD552C898F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2332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3982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4747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5583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7917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6254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6010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9623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64409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1136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0754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31963-1359-4BBF-8C36-B78105573A69}" type="datetimeFigureOut">
              <a:rPr lang="es-ES" smtClean="0"/>
              <a:t>15/07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0A10B5-53F4-4DE7-8895-82816E31DD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3090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upo 42">
            <a:extLst>
              <a:ext uri="{FF2B5EF4-FFF2-40B4-BE49-F238E27FC236}">
                <a16:creationId xmlns:a16="http://schemas.microsoft.com/office/drawing/2014/main" id="{23B0A55B-C8E1-9F8B-30DF-24245BBF8101}"/>
              </a:ext>
            </a:extLst>
          </p:cNvPr>
          <p:cNvGrpSpPr/>
          <p:nvPr/>
        </p:nvGrpSpPr>
        <p:grpSpPr>
          <a:xfrm>
            <a:off x="10683467" y="4100220"/>
            <a:ext cx="6083899" cy="4380455"/>
            <a:chOff x="90890" y="5074554"/>
            <a:chExt cx="6083899" cy="4380455"/>
          </a:xfrm>
        </p:grpSpPr>
        <p:pic>
          <p:nvPicPr>
            <p:cNvPr id="9" name="Imagen 8" descr="Un collar de flores&#10;&#10;Descripción generada automáticamente con confianza media">
              <a:extLst>
                <a:ext uri="{FF2B5EF4-FFF2-40B4-BE49-F238E27FC236}">
                  <a16:creationId xmlns:a16="http://schemas.microsoft.com/office/drawing/2014/main" id="{793E8338-1EF6-9989-18E3-C7710E22F2D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890" y="5121484"/>
              <a:ext cx="6083899" cy="4333525"/>
            </a:xfrm>
            <a:prstGeom prst="rect">
              <a:avLst/>
            </a:prstGeom>
          </p:spPr>
        </p:pic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20FA7312-CD72-B8D4-B594-8CB52578BB6B}"/>
                </a:ext>
              </a:extLst>
            </p:cNvPr>
            <p:cNvSpPr txBox="1"/>
            <p:nvPr/>
          </p:nvSpPr>
          <p:spPr>
            <a:xfrm>
              <a:off x="1713699" y="5074554"/>
              <a:ext cx="24851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err="1"/>
                <a:t>Crucian</a:t>
              </a:r>
              <a:r>
                <a:rPr lang="es-ES" sz="1400" dirty="0"/>
                <a:t> </a:t>
              </a:r>
              <a:r>
                <a:rPr lang="es-ES" sz="1400" dirty="0" err="1"/>
                <a:t>carp</a:t>
              </a:r>
              <a:r>
                <a:rPr lang="es-ES" sz="1400" dirty="0"/>
                <a:t>  HERC7 UVH33433</a:t>
              </a:r>
            </a:p>
          </p:txBody>
        </p:sp>
      </p:grpSp>
      <p:grpSp>
        <p:nvGrpSpPr>
          <p:cNvPr id="3" name="Grupo 2">
            <a:extLst>
              <a:ext uri="{FF2B5EF4-FFF2-40B4-BE49-F238E27FC236}">
                <a16:creationId xmlns:a16="http://schemas.microsoft.com/office/drawing/2014/main" id="{B3972B57-6189-9D37-13EB-0F621C400C8B}"/>
              </a:ext>
            </a:extLst>
          </p:cNvPr>
          <p:cNvGrpSpPr/>
          <p:nvPr/>
        </p:nvGrpSpPr>
        <p:grpSpPr>
          <a:xfrm>
            <a:off x="1264746" y="8030098"/>
            <a:ext cx="9736489" cy="4831224"/>
            <a:chOff x="-1900242" y="4662653"/>
            <a:chExt cx="9736489" cy="4831224"/>
          </a:xfrm>
        </p:grpSpPr>
        <p:pic>
          <p:nvPicPr>
            <p:cNvPr id="46" name="Imagen 45" descr="Una flor color blanco con letras negras en un fondo negro&#10;&#10;Descripción generada automáticamente con confianza media">
              <a:extLst>
                <a:ext uri="{FF2B5EF4-FFF2-40B4-BE49-F238E27FC236}">
                  <a16:creationId xmlns:a16="http://schemas.microsoft.com/office/drawing/2014/main" id="{168BD127-1D5F-A543-4A38-50CD552C898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900242" y="4662653"/>
              <a:ext cx="9736489" cy="4831224"/>
            </a:xfrm>
            <a:prstGeom prst="rect">
              <a:avLst/>
            </a:prstGeom>
          </p:spPr>
        </p:pic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C201AEEF-13F0-26AD-2420-E2AB16722448}"/>
                </a:ext>
              </a:extLst>
            </p:cNvPr>
            <p:cNvSpPr txBox="1"/>
            <p:nvPr/>
          </p:nvSpPr>
          <p:spPr>
            <a:xfrm>
              <a:off x="1129552" y="4984605"/>
              <a:ext cx="26661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Human</a:t>
              </a:r>
              <a:r>
                <a:rPr lang="es-ES" sz="1400" i="1" dirty="0"/>
                <a:t> </a:t>
              </a:r>
              <a:r>
                <a:rPr lang="es-ES" sz="1400" dirty="0"/>
                <a:t>HERC3 ENSP00000385684</a:t>
              </a:r>
            </a:p>
          </p:txBody>
        </p:sp>
      </p:grpSp>
      <p:pic>
        <p:nvPicPr>
          <p:cNvPr id="8" name="Imagen 7" descr="Un collar de flores&#10;&#10;Descripción generada automáticamente con confianza baja">
            <a:extLst>
              <a:ext uri="{FF2B5EF4-FFF2-40B4-BE49-F238E27FC236}">
                <a16:creationId xmlns:a16="http://schemas.microsoft.com/office/drawing/2014/main" id="{47F6E0BB-2B7D-4DEF-225E-BBA244C2DDB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5794" y="7974459"/>
            <a:ext cx="7933466" cy="4831224"/>
          </a:xfrm>
          <a:prstGeom prst="rect">
            <a:avLst/>
          </a:prstGeom>
        </p:spPr>
      </p:pic>
      <p:grpSp>
        <p:nvGrpSpPr>
          <p:cNvPr id="31" name="Grupo 30">
            <a:extLst>
              <a:ext uri="{FF2B5EF4-FFF2-40B4-BE49-F238E27FC236}">
                <a16:creationId xmlns:a16="http://schemas.microsoft.com/office/drawing/2014/main" id="{8BDDB484-72FA-CB90-687A-0D747B85186E}"/>
              </a:ext>
            </a:extLst>
          </p:cNvPr>
          <p:cNvGrpSpPr/>
          <p:nvPr/>
        </p:nvGrpSpPr>
        <p:grpSpPr>
          <a:xfrm>
            <a:off x="1104778" y="12108114"/>
            <a:ext cx="9736489" cy="5224195"/>
            <a:chOff x="-783504" y="11679995"/>
            <a:chExt cx="9736489" cy="5224195"/>
          </a:xfrm>
        </p:grpSpPr>
        <p:pic>
          <p:nvPicPr>
            <p:cNvPr id="29" name="Imagen 28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4397ADA7-A06F-92FF-7EE5-EDB2B8DA994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783504" y="11896179"/>
              <a:ext cx="9736489" cy="5008011"/>
            </a:xfrm>
            <a:prstGeom prst="rect">
              <a:avLst/>
            </a:prstGeom>
          </p:spPr>
        </p:pic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B74FB3E0-5429-88F5-B939-05975E563AAF}"/>
                </a:ext>
              </a:extLst>
            </p:cNvPr>
            <p:cNvSpPr txBox="1"/>
            <p:nvPr/>
          </p:nvSpPr>
          <p:spPr>
            <a:xfrm>
              <a:off x="2501077" y="11679995"/>
              <a:ext cx="28023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Human HERC5 ENSP00000264350.3</a:t>
              </a:r>
            </a:p>
          </p:txBody>
        </p:sp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04810AC8-7D5F-50D1-50F1-E295D5B109A4}"/>
              </a:ext>
            </a:extLst>
          </p:cNvPr>
          <p:cNvSpPr txBox="1"/>
          <p:nvPr/>
        </p:nvSpPr>
        <p:spPr>
          <a:xfrm>
            <a:off x="56202" y="1225769"/>
            <a:ext cx="170718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Data S1: HERC7 3D modelling of protein structure shows tertiary structure conservation.</a:t>
            </a:r>
            <a:r>
              <a:rPr lang="en-GB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3D modelling of European sea bass HERC7 putative protein and zebrafish, crucian carp and human orthologues was performed with Swiss-Model tool. Correspondence with secondary structure was detailed as α-helix with a grey helixes and β-sheet with green arrows. </a:t>
            </a:r>
            <a:endParaRPr lang="es-ES" sz="2800" b="1" dirty="0"/>
          </a:p>
        </p:txBody>
      </p:sp>
      <p:grpSp>
        <p:nvGrpSpPr>
          <p:cNvPr id="26" name="Grupo 25">
            <a:extLst>
              <a:ext uri="{FF2B5EF4-FFF2-40B4-BE49-F238E27FC236}">
                <a16:creationId xmlns:a16="http://schemas.microsoft.com/office/drawing/2014/main" id="{27190336-0F2D-10A4-AA68-1478F89C2F0C}"/>
              </a:ext>
            </a:extLst>
          </p:cNvPr>
          <p:cNvGrpSpPr/>
          <p:nvPr/>
        </p:nvGrpSpPr>
        <p:grpSpPr>
          <a:xfrm>
            <a:off x="-595090" y="4155859"/>
            <a:ext cx="6839092" cy="4653204"/>
            <a:chOff x="366444" y="8074262"/>
            <a:chExt cx="6839092" cy="4653204"/>
          </a:xfrm>
        </p:grpSpPr>
        <p:pic>
          <p:nvPicPr>
            <p:cNvPr id="11" name="Imagen 10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605E8FD9-072E-2A16-0070-905DAE083A9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6444" y="8099816"/>
              <a:ext cx="6839092" cy="4627650"/>
            </a:xfrm>
            <a:prstGeom prst="rect">
              <a:avLst/>
            </a:prstGeom>
          </p:spPr>
        </p:pic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E2502205-DBD4-03BF-CC17-F907E32AFA4C}"/>
                </a:ext>
              </a:extLst>
            </p:cNvPr>
            <p:cNvSpPr txBox="1"/>
            <p:nvPr/>
          </p:nvSpPr>
          <p:spPr>
            <a:xfrm>
              <a:off x="2189462" y="8074262"/>
              <a:ext cx="28650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err="1"/>
                <a:t>European</a:t>
              </a:r>
              <a:r>
                <a:rPr lang="es-ES" sz="1400" dirty="0"/>
                <a:t> sea </a:t>
              </a:r>
              <a:r>
                <a:rPr lang="es-ES" sz="1400" dirty="0" err="1"/>
                <a:t>bass</a:t>
              </a:r>
              <a:r>
                <a:rPr lang="es-ES" sz="1400" dirty="0"/>
                <a:t> HERC7 OR750555</a:t>
              </a:r>
            </a:p>
          </p:txBody>
        </p:sp>
      </p:grpSp>
      <p:grpSp>
        <p:nvGrpSpPr>
          <p:cNvPr id="42" name="Grupo 41">
            <a:extLst>
              <a:ext uri="{FF2B5EF4-FFF2-40B4-BE49-F238E27FC236}">
                <a16:creationId xmlns:a16="http://schemas.microsoft.com/office/drawing/2014/main" id="{D29E2F99-25E2-F445-A6B7-C40FDA189906}"/>
              </a:ext>
            </a:extLst>
          </p:cNvPr>
          <p:cNvGrpSpPr/>
          <p:nvPr/>
        </p:nvGrpSpPr>
        <p:grpSpPr>
          <a:xfrm>
            <a:off x="4352178" y="4155859"/>
            <a:ext cx="7393531" cy="4590125"/>
            <a:chOff x="8009778" y="1055825"/>
            <a:chExt cx="7393531" cy="4590125"/>
          </a:xfrm>
        </p:grpSpPr>
        <p:pic>
          <p:nvPicPr>
            <p:cNvPr id="7" name="Imagen 6" descr="Un conjunto de letras blancas en un fondo blanco&#10;&#10;Descripción generada automáticamente con confianza media">
              <a:extLst>
                <a:ext uri="{FF2B5EF4-FFF2-40B4-BE49-F238E27FC236}">
                  <a16:creationId xmlns:a16="http://schemas.microsoft.com/office/drawing/2014/main" id="{23663318-3064-A602-411C-49C6E45BA6C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09778" y="1119872"/>
              <a:ext cx="7393531" cy="4526078"/>
            </a:xfrm>
            <a:prstGeom prst="rect">
              <a:avLst/>
            </a:prstGeom>
          </p:spPr>
        </p:pic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FC9AFFF8-2518-24DF-A5B8-103762DD1480}"/>
                </a:ext>
              </a:extLst>
            </p:cNvPr>
            <p:cNvSpPr txBox="1"/>
            <p:nvPr/>
          </p:nvSpPr>
          <p:spPr>
            <a:xfrm>
              <a:off x="10467693" y="1055825"/>
              <a:ext cx="26795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 err="1"/>
                <a:t>Zebrafish</a:t>
              </a:r>
              <a:r>
                <a:rPr lang="es-ES" sz="1400" i="1" dirty="0"/>
                <a:t> </a:t>
              </a:r>
              <a:r>
                <a:rPr lang="es-ES" sz="1400" dirty="0"/>
                <a:t>HERC7c XP 021330683.1</a:t>
              </a:r>
            </a:p>
          </p:txBody>
        </p:sp>
      </p:grpSp>
      <p:grpSp>
        <p:nvGrpSpPr>
          <p:cNvPr id="35" name="Grupo 34">
            <a:extLst>
              <a:ext uri="{FF2B5EF4-FFF2-40B4-BE49-F238E27FC236}">
                <a16:creationId xmlns:a16="http://schemas.microsoft.com/office/drawing/2014/main" id="{D42E89A3-97D4-AB03-E610-2F5D3D4C7538}"/>
              </a:ext>
            </a:extLst>
          </p:cNvPr>
          <p:cNvGrpSpPr/>
          <p:nvPr/>
        </p:nvGrpSpPr>
        <p:grpSpPr>
          <a:xfrm>
            <a:off x="6333271" y="12019277"/>
            <a:ext cx="10529571" cy="5008011"/>
            <a:chOff x="3958758" y="11582595"/>
            <a:chExt cx="10529571" cy="5008011"/>
          </a:xfrm>
        </p:grpSpPr>
        <p:pic>
          <p:nvPicPr>
            <p:cNvPr id="34" name="Imagen 33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BFED11C3-99FF-A974-9B56-3FE91429B27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58758" y="11582595"/>
              <a:ext cx="10529571" cy="5008011"/>
            </a:xfrm>
            <a:prstGeom prst="rect">
              <a:avLst/>
            </a:prstGeom>
          </p:spPr>
        </p:pic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6CAEC285-73C9-63CD-3345-3E2F3A274BAB}"/>
                </a:ext>
              </a:extLst>
            </p:cNvPr>
            <p:cNvSpPr txBox="1"/>
            <p:nvPr/>
          </p:nvSpPr>
          <p:spPr>
            <a:xfrm>
              <a:off x="7454507" y="11679995"/>
              <a:ext cx="28023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/>
                <a:t>Human</a:t>
              </a:r>
              <a:r>
                <a:rPr lang="es-ES" sz="1400" i="1" dirty="0"/>
                <a:t> </a:t>
              </a:r>
              <a:r>
                <a:rPr lang="es-ES" sz="1400" dirty="0"/>
                <a:t>HERC6 ENSP00000264346.8</a:t>
              </a:r>
            </a:p>
          </p:txBody>
        </p:sp>
      </p:grpSp>
      <p:sp>
        <p:nvSpPr>
          <p:cNvPr id="4" name="CuadroTexto 3">
            <a:extLst>
              <a:ext uri="{FF2B5EF4-FFF2-40B4-BE49-F238E27FC236}">
                <a16:creationId xmlns:a16="http://schemas.microsoft.com/office/drawing/2014/main" id="{35C65687-1C66-F067-6E6B-9D5FB5AA8447}"/>
              </a:ext>
            </a:extLst>
          </p:cNvPr>
          <p:cNvSpPr txBox="1"/>
          <p:nvPr/>
        </p:nvSpPr>
        <p:spPr>
          <a:xfrm>
            <a:off x="9891770" y="8358976"/>
            <a:ext cx="28023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/>
              <a:t>Human HERC4 ENSP00000362804.4</a:t>
            </a:r>
          </a:p>
        </p:txBody>
      </p:sp>
    </p:spTree>
    <p:extLst>
      <p:ext uri="{BB962C8B-B14F-4D97-AF65-F5344CB8AC3E}">
        <p14:creationId xmlns:p14="http://schemas.microsoft.com/office/powerpoint/2010/main" val="7033919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9</TotalTime>
  <Words>81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YULEMA VALERO CUESTA</dc:creator>
  <cp:lastModifiedBy>MDPI</cp:lastModifiedBy>
  <cp:revision>4</cp:revision>
  <dcterms:created xsi:type="dcterms:W3CDTF">2023-12-13T22:27:52Z</dcterms:created>
  <dcterms:modified xsi:type="dcterms:W3CDTF">2024-07-15T12:57:52Z</dcterms:modified>
</cp:coreProperties>
</file>